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0" r:id="rId3"/>
    <p:sldId id="261" r:id="rId4"/>
    <p:sldId id="264" r:id="rId5"/>
    <p:sldId id="262" r:id="rId6"/>
    <p:sldId id="263" r:id="rId7"/>
    <p:sldId id="265" r:id="rId8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41" autoAdjust="0"/>
    <p:restoredTop sz="94528" autoAdjust="0"/>
  </p:normalViewPr>
  <p:slideViewPr>
    <p:cSldViewPr>
      <p:cViewPr>
        <p:scale>
          <a:sx n="125" d="100"/>
          <a:sy n="125" d="100"/>
        </p:scale>
        <p:origin x="1592" y="9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4/6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tiff"/><Relationship Id="rId5" Type="http://schemas.openxmlformats.org/officeDocument/2006/relationships/image" Target="../media/image21.png"/><Relationship Id="rId4" Type="http://schemas.openxmlformats.org/officeDocument/2006/relationships/image" Target="../media/image2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tiff"/><Relationship Id="rId4" Type="http://schemas.openxmlformats.org/officeDocument/2006/relationships/image" Target="../media/image2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36E9F9EF-A7DC-3260-5311-587DB7DE61B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84054"/>
            <a:ext cx="2340864" cy="156057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231E3B48-6303-4EC2-2340-3294E736AFC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75462" y="2145342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6C2987F7-F307-BBC9-E43A-98DFFBE47C4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2144986"/>
            <a:ext cx="2341397" cy="156093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BEDA2FB-27CD-4D8A-C404-9A9CF401456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74929" y="508168"/>
            <a:ext cx="2341397" cy="1560932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6FF8F4DC-9D45-D0E9-F826-13EEB09C4526}"/>
              </a:ext>
            </a:extLst>
          </p:cNvPr>
          <p:cNvSpPr/>
          <p:nvPr/>
        </p:nvSpPr>
        <p:spPr>
          <a:xfrm>
            <a:off x="835441" y="1294146"/>
            <a:ext cx="793359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7C99695-39A5-5AAF-1516-BC9830C1AF0F}"/>
              </a:ext>
            </a:extLst>
          </p:cNvPr>
          <p:cNvSpPr/>
          <p:nvPr/>
        </p:nvSpPr>
        <p:spPr>
          <a:xfrm>
            <a:off x="2924945" y="1294146"/>
            <a:ext cx="720080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666CB5-6AC8-7AFC-9D74-26C2A13F4866}"/>
              </a:ext>
            </a:extLst>
          </p:cNvPr>
          <p:cNvSpPr/>
          <p:nvPr/>
        </p:nvSpPr>
        <p:spPr>
          <a:xfrm>
            <a:off x="836712" y="2961387"/>
            <a:ext cx="720080" cy="1537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EFD7747-6C16-402B-A1E6-F7894DBDDF2B}"/>
              </a:ext>
            </a:extLst>
          </p:cNvPr>
          <p:cNvSpPr/>
          <p:nvPr/>
        </p:nvSpPr>
        <p:spPr>
          <a:xfrm>
            <a:off x="3284984" y="2925630"/>
            <a:ext cx="833641" cy="21736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A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  <a:endParaRPr lang="zh-CN" altLang="en-US" sz="1400"/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55690" y="459150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sp>
        <p:nvSpPr>
          <p:cNvPr id="40" name="TextBox 18">
            <a:extLst>
              <a:ext uri="{FF2B5EF4-FFF2-40B4-BE49-F238E27FC236}">
                <a16:creationId xmlns:a16="http://schemas.microsoft.com/office/drawing/2014/main" id="{2208CFF9-CA0A-905C-C135-6FB984CBF757}"/>
              </a:ext>
            </a:extLst>
          </p:cNvPr>
          <p:cNvSpPr txBox="1"/>
          <p:nvPr/>
        </p:nvSpPr>
        <p:spPr>
          <a:xfrm>
            <a:off x="2442592" y="208509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>
            <a:extLst>
              <a:ext uri="{FF2B5EF4-FFF2-40B4-BE49-F238E27FC236}">
                <a16:creationId xmlns:a16="http://schemas.microsoft.com/office/drawing/2014/main" id="{94720099-E4F6-F196-F38E-9DC47F93F2B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8129" y="398064"/>
            <a:ext cx="2340864" cy="1560576"/>
          </a:xfrm>
          <a:prstGeom prst="rect">
            <a:avLst/>
          </a:prstGeom>
        </p:spPr>
      </p:pic>
      <p:sp>
        <p:nvSpPr>
          <p:cNvPr id="24" name="TextBox 9">
            <a:extLst>
              <a:ext uri="{FF2B5EF4-FFF2-40B4-BE49-F238E27FC236}">
                <a16:creationId xmlns:a16="http://schemas.microsoft.com/office/drawing/2014/main" id="{42967B9E-2833-89BB-D357-F40B8C0FB4E3}"/>
              </a:ext>
            </a:extLst>
          </p:cNvPr>
          <p:cNvSpPr txBox="1"/>
          <p:nvPr/>
        </p:nvSpPr>
        <p:spPr>
          <a:xfrm>
            <a:off x="-34354" y="-25970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B</a:t>
            </a:r>
            <a:endParaRPr lang="zh-CN" altLang="en-US" sz="140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286DF2A-C671-4374-9626-D63322EB009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6554" y="2013303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C3F18E5-35C1-4BA0-D4E6-AFE389BE33C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6612" y="398064"/>
            <a:ext cx="2340864" cy="156057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D015E14-0032-5B57-F40E-F28A6E569E6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8016" y="2013303"/>
            <a:ext cx="2340864" cy="1560576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D8B88A07-B77D-06C3-3E36-CA618D60A2EC}"/>
              </a:ext>
            </a:extLst>
          </p:cNvPr>
          <p:cNvSpPr/>
          <p:nvPr/>
        </p:nvSpPr>
        <p:spPr>
          <a:xfrm>
            <a:off x="836712" y="1183399"/>
            <a:ext cx="504057" cy="13155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5EBCFA7-8A6F-44B2-1D1E-C56349D6C09B}"/>
              </a:ext>
            </a:extLst>
          </p:cNvPr>
          <p:cNvSpPr/>
          <p:nvPr/>
        </p:nvSpPr>
        <p:spPr>
          <a:xfrm>
            <a:off x="3356992" y="1208361"/>
            <a:ext cx="432048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41CABAD3-DE8E-ABB8-E263-92B70109AD4F}"/>
              </a:ext>
            </a:extLst>
          </p:cNvPr>
          <p:cNvSpPr/>
          <p:nvPr/>
        </p:nvSpPr>
        <p:spPr>
          <a:xfrm>
            <a:off x="714569" y="2820420"/>
            <a:ext cx="504056" cy="1537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A54D6AEC-2746-DB31-B1C4-3741A61C90B1}"/>
              </a:ext>
            </a:extLst>
          </p:cNvPr>
          <p:cNvSpPr/>
          <p:nvPr/>
        </p:nvSpPr>
        <p:spPr>
          <a:xfrm>
            <a:off x="3356992" y="2820420"/>
            <a:ext cx="576064" cy="21736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13609BEB-C82A-BA6B-8FC5-7B05E7A66ECD}"/>
              </a:ext>
            </a:extLst>
          </p:cNvPr>
          <p:cNvSpPr txBox="1"/>
          <p:nvPr/>
        </p:nvSpPr>
        <p:spPr>
          <a:xfrm>
            <a:off x="-63657" y="2116763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  <a:endParaRPr lang="zh-CN" altLang="en-US" sz="1400"/>
          </a:p>
        </p:txBody>
      </p:sp>
      <p:sp>
        <p:nvSpPr>
          <p:cNvPr id="17" name="TextBox 12">
            <a:extLst>
              <a:ext uri="{FF2B5EF4-FFF2-40B4-BE49-F238E27FC236}">
                <a16:creationId xmlns:a16="http://schemas.microsoft.com/office/drawing/2014/main" id="{C188BACF-260A-38E2-2D9F-2671FF8A6D8B}"/>
              </a:ext>
            </a:extLst>
          </p:cNvPr>
          <p:cNvSpPr txBox="1"/>
          <p:nvPr/>
        </p:nvSpPr>
        <p:spPr>
          <a:xfrm>
            <a:off x="-55690" y="459150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sp>
        <p:nvSpPr>
          <p:cNvPr id="18" name="TextBox 18">
            <a:extLst>
              <a:ext uri="{FF2B5EF4-FFF2-40B4-BE49-F238E27FC236}">
                <a16:creationId xmlns:a16="http://schemas.microsoft.com/office/drawing/2014/main" id="{441F76EC-1159-8395-9DE3-B3B6CD775BAF}"/>
              </a:ext>
            </a:extLst>
          </p:cNvPr>
          <p:cNvSpPr txBox="1"/>
          <p:nvPr/>
        </p:nvSpPr>
        <p:spPr>
          <a:xfrm>
            <a:off x="2442592" y="208509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25" name="TextBox 18">
            <a:extLst>
              <a:ext uri="{FF2B5EF4-FFF2-40B4-BE49-F238E27FC236}">
                <a16:creationId xmlns:a16="http://schemas.microsoft.com/office/drawing/2014/main" id="{5DD03F4E-EA5D-3DC9-C190-25A19D46D79F}"/>
              </a:ext>
            </a:extLst>
          </p:cNvPr>
          <p:cNvSpPr txBox="1"/>
          <p:nvPr/>
        </p:nvSpPr>
        <p:spPr>
          <a:xfrm>
            <a:off x="2396554" y="448552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</p:spTree>
    <p:extLst>
      <p:ext uri="{BB962C8B-B14F-4D97-AF65-F5344CB8AC3E}">
        <p14:creationId xmlns:p14="http://schemas.microsoft.com/office/powerpoint/2010/main" val="21112953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2D8CA50-764D-BA2C-C863-8FFB87FF148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034" y="2181099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D59949D-2842-2341-5DFF-1A321A75B0C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568786"/>
            <a:ext cx="2340864" cy="156057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3AE6AE6-28FD-876D-5A97-20EF679D4B0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04472" y="568786"/>
            <a:ext cx="2341397" cy="1560932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6FF8F4DC-9D45-D0E9-F826-13EEB09C4526}"/>
              </a:ext>
            </a:extLst>
          </p:cNvPr>
          <p:cNvSpPr/>
          <p:nvPr/>
        </p:nvSpPr>
        <p:spPr>
          <a:xfrm>
            <a:off x="811962" y="1349074"/>
            <a:ext cx="793359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7C99695-39A5-5AAF-1516-BC9830C1AF0F}"/>
              </a:ext>
            </a:extLst>
          </p:cNvPr>
          <p:cNvSpPr/>
          <p:nvPr/>
        </p:nvSpPr>
        <p:spPr>
          <a:xfrm>
            <a:off x="3340577" y="1344420"/>
            <a:ext cx="720080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666CB5-6AC8-7AFC-9D74-26C2A13F4866}"/>
              </a:ext>
            </a:extLst>
          </p:cNvPr>
          <p:cNvSpPr/>
          <p:nvPr/>
        </p:nvSpPr>
        <p:spPr>
          <a:xfrm>
            <a:off x="908720" y="2961387"/>
            <a:ext cx="720080" cy="1537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1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E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3608" y="573439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32464" y="568786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</p:spTree>
    <p:extLst>
      <p:ext uri="{BB962C8B-B14F-4D97-AF65-F5344CB8AC3E}">
        <p14:creationId xmlns:p14="http://schemas.microsoft.com/office/powerpoint/2010/main" val="4082526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14BEBEB3-B5E1-328A-71E4-86275A10873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400" y="2134371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79A7DE5B-5152-C329-B87F-E75FE34E564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3350" y="488148"/>
            <a:ext cx="2341397" cy="156093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923589D-BFB4-F612-00F1-41408D57227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79858" y="488504"/>
            <a:ext cx="2340864" cy="1560576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6FF8F4DC-9D45-D0E9-F826-13EEB09C4526}"/>
              </a:ext>
            </a:extLst>
          </p:cNvPr>
          <p:cNvSpPr/>
          <p:nvPr/>
        </p:nvSpPr>
        <p:spPr>
          <a:xfrm>
            <a:off x="787368" y="1208584"/>
            <a:ext cx="793359" cy="15070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7C99695-39A5-5AAF-1516-BC9830C1AF0F}"/>
              </a:ext>
            </a:extLst>
          </p:cNvPr>
          <p:cNvSpPr/>
          <p:nvPr/>
        </p:nvSpPr>
        <p:spPr>
          <a:xfrm>
            <a:off x="3645024" y="1352600"/>
            <a:ext cx="720080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5E666CB5-6AC8-7AFC-9D74-26C2A13F4866}"/>
              </a:ext>
            </a:extLst>
          </p:cNvPr>
          <p:cNvSpPr/>
          <p:nvPr/>
        </p:nvSpPr>
        <p:spPr>
          <a:xfrm>
            <a:off x="836712" y="2936776"/>
            <a:ext cx="720080" cy="1537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G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3608" y="573439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32464" y="568786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</p:spTree>
    <p:extLst>
      <p:ext uri="{BB962C8B-B14F-4D97-AF65-F5344CB8AC3E}">
        <p14:creationId xmlns:p14="http://schemas.microsoft.com/office/powerpoint/2010/main" val="10565566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B91EF28E-CD02-189A-510D-3A032F82A3C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0479" y="568786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3EF0D45-EBEA-7A39-03E8-2D59ABAAAF5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528296" y="568786"/>
            <a:ext cx="2340864" cy="1560576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6FF8F4DC-9D45-D0E9-F826-13EEB09C4526}"/>
              </a:ext>
            </a:extLst>
          </p:cNvPr>
          <p:cNvSpPr/>
          <p:nvPr/>
        </p:nvSpPr>
        <p:spPr>
          <a:xfrm>
            <a:off x="917526" y="1344420"/>
            <a:ext cx="600814" cy="1813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7C99695-39A5-5AAF-1516-BC9830C1AF0F}"/>
              </a:ext>
            </a:extLst>
          </p:cNvPr>
          <p:cNvSpPr/>
          <p:nvPr/>
        </p:nvSpPr>
        <p:spPr>
          <a:xfrm>
            <a:off x="3461938" y="1349074"/>
            <a:ext cx="576064" cy="176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I</a:t>
            </a:r>
            <a:endParaRPr lang="zh-CN" altLang="en-US" sz="1400"/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3608" y="573439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509417" y="568786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  <a:endParaRPr lang="zh-CN" altLang="en-US" sz="140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1F5571A-32A9-4FCF-1A1D-DAC5F516607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6876" y="2168288"/>
            <a:ext cx="2340864" cy="1560576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E746CEF8-E766-CE46-3A7F-F5A6087E18DC}"/>
              </a:ext>
            </a:extLst>
          </p:cNvPr>
          <p:cNvSpPr/>
          <p:nvPr/>
        </p:nvSpPr>
        <p:spPr>
          <a:xfrm>
            <a:off x="836711" y="2948332"/>
            <a:ext cx="648073" cy="15606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12CBA1-0098-0CA3-5E3F-1B24090EE79F}"/>
              </a:ext>
            </a:extLst>
          </p:cNvPr>
          <p:cNvSpPr txBox="1"/>
          <p:nvPr/>
        </p:nvSpPr>
        <p:spPr>
          <a:xfrm>
            <a:off x="-71223" y="2168288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19912773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A9FDC008-2692-0BAD-AEDE-0DFED6BE4AE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33" y="2025981"/>
            <a:ext cx="2340864" cy="15605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372C62A-6D25-3FBD-46A8-0813FCCD359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05005" y="344488"/>
            <a:ext cx="2341397" cy="1560932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B2C463B-A6ED-AD0D-DC8B-A4E827A7FA0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344488"/>
            <a:ext cx="2341397" cy="1560932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6FF8F4DC-9D45-D0E9-F826-13EEB09C4526}"/>
              </a:ext>
            </a:extLst>
          </p:cNvPr>
          <p:cNvSpPr/>
          <p:nvPr/>
        </p:nvSpPr>
        <p:spPr>
          <a:xfrm>
            <a:off x="640831" y="1082988"/>
            <a:ext cx="411905" cy="36004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37C99695-39A5-5AAF-1516-BC9830C1AF0F}"/>
              </a:ext>
            </a:extLst>
          </p:cNvPr>
          <p:cNvSpPr/>
          <p:nvPr/>
        </p:nvSpPr>
        <p:spPr>
          <a:xfrm>
            <a:off x="3168433" y="1154995"/>
            <a:ext cx="404583" cy="16956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78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M</a:t>
            </a:r>
            <a:endParaRPr lang="zh-CN" altLang="en-US" sz="1400"/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63608" y="375835"/>
            <a:ext cx="4796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lag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429016" y="371226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  <a:endParaRPr lang="zh-CN" altLang="en-US" sz="1400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E746CEF8-E766-CE46-3A7F-F5A6087E18DC}"/>
              </a:ext>
            </a:extLst>
          </p:cNvPr>
          <p:cNvSpPr/>
          <p:nvPr/>
        </p:nvSpPr>
        <p:spPr>
          <a:xfrm>
            <a:off x="980728" y="2767006"/>
            <a:ext cx="396044" cy="23132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12CBA1-0098-0CA3-5E3F-1B24090EE79F}"/>
              </a:ext>
            </a:extLst>
          </p:cNvPr>
          <p:cNvSpPr txBox="1"/>
          <p:nvPr/>
        </p:nvSpPr>
        <p:spPr>
          <a:xfrm>
            <a:off x="-71223" y="2027639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c-Ju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0D41E68-4D94-1128-C97B-5A88F5B6916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3701823"/>
            <a:ext cx="2341397" cy="156093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81883A47-5449-46B7-8D55-16F6D41062F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14952" y="2048470"/>
            <a:ext cx="2340864" cy="1560576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AF376698-0431-C2B3-F21A-BEAFDB73E580}"/>
              </a:ext>
            </a:extLst>
          </p:cNvPr>
          <p:cNvSpPr/>
          <p:nvPr/>
        </p:nvSpPr>
        <p:spPr>
          <a:xfrm>
            <a:off x="3168432" y="2828758"/>
            <a:ext cx="404583" cy="16956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D96910C-E2C4-0BAC-0DC9-BD8709EDEE6A}"/>
              </a:ext>
            </a:extLst>
          </p:cNvPr>
          <p:cNvSpPr/>
          <p:nvPr/>
        </p:nvSpPr>
        <p:spPr>
          <a:xfrm>
            <a:off x="1052736" y="4496006"/>
            <a:ext cx="404583" cy="16956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TextBox 8">
            <a:extLst>
              <a:ext uri="{FF2B5EF4-FFF2-40B4-BE49-F238E27FC236}">
                <a16:creationId xmlns:a16="http://schemas.microsoft.com/office/drawing/2014/main" id="{42889CFB-6461-AFA2-4700-B58B704203AE}"/>
              </a:ext>
            </a:extLst>
          </p:cNvPr>
          <p:cNvSpPr txBox="1"/>
          <p:nvPr/>
        </p:nvSpPr>
        <p:spPr>
          <a:xfrm>
            <a:off x="-19929" y="3696307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6" name="TextBox 8">
            <a:extLst>
              <a:ext uri="{FF2B5EF4-FFF2-40B4-BE49-F238E27FC236}">
                <a16:creationId xmlns:a16="http://schemas.microsoft.com/office/drawing/2014/main" id="{B9507281-259F-8A5A-E9BD-7FC89B26457D}"/>
              </a:ext>
            </a:extLst>
          </p:cNvPr>
          <p:cNvSpPr txBox="1"/>
          <p:nvPr/>
        </p:nvSpPr>
        <p:spPr>
          <a:xfrm>
            <a:off x="2405005" y="2024415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</p:spTree>
    <p:extLst>
      <p:ext uri="{BB962C8B-B14F-4D97-AF65-F5344CB8AC3E}">
        <p14:creationId xmlns:p14="http://schemas.microsoft.com/office/powerpoint/2010/main" val="23325693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>
            <a:extLst>
              <a:ext uri="{FF2B5EF4-FFF2-40B4-BE49-F238E27FC236}">
                <a16:creationId xmlns:a16="http://schemas.microsoft.com/office/drawing/2014/main" id="{EB3E599D-F35E-1D72-697A-F47BAA16282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2486" y="399771"/>
            <a:ext cx="2340864" cy="156057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A6A470A-0CB9-B7CA-3D46-A1058AFB602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33355" y="2145342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5ECB4AD-44A9-63F2-D0EF-88BE6951750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16370" y="2145342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1C964AFB-510E-2188-E8C7-3F152FD6D19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6048" y="399771"/>
            <a:ext cx="2340864" cy="1560576"/>
          </a:xfrm>
          <a:prstGeom prst="rect">
            <a:avLst/>
          </a:prstGeom>
        </p:spPr>
      </p:pic>
      <p:sp>
        <p:nvSpPr>
          <p:cNvPr id="24" name="矩形 23">
            <a:extLst>
              <a:ext uri="{FF2B5EF4-FFF2-40B4-BE49-F238E27FC236}">
                <a16:creationId xmlns:a16="http://schemas.microsoft.com/office/drawing/2014/main" id="{5E666CB5-6AC8-7AFC-9D74-26C2A13F4866}"/>
              </a:ext>
            </a:extLst>
          </p:cNvPr>
          <p:cNvSpPr/>
          <p:nvPr/>
        </p:nvSpPr>
        <p:spPr>
          <a:xfrm>
            <a:off x="476672" y="2871034"/>
            <a:ext cx="1517468" cy="24405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9EFD7747-6C16-402B-A1E6-F7894DBDDF2B}"/>
              </a:ext>
            </a:extLst>
          </p:cNvPr>
          <p:cNvSpPr/>
          <p:nvPr/>
        </p:nvSpPr>
        <p:spPr>
          <a:xfrm>
            <a:off x="2924944" y="2871034"/>
            <a:ext cx="1465335" cy="24405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5P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  <a:endParaRPr lang="zh-CN" altLang="en-US" sz="1400"/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7933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TNFAIP2</a:t>
            </a:r>
            <a:endParaRPr lang="zh-CN" altLang="en-US" sz="1400"/>
          </a:p>
        </p:txBody>
      </p:sp>
      <p:sp>
        <p:nvSpPr>
          <p:cNvPr id="40" name="TextBox 18">
            <a:extLst>
              <a:ext uri="{FF2B5EF4-FFF2-40B4-BE49-F238E27FC236}">
                <a16:creationId xmlns:a16="http://schemas.microsoft.com/office/drawing/2014/main" id="{2208CFF9-CA0A-905C-C135-6FB984CBF757}"/>
              </a:ext>
            </a:extLst>
          </p:cNvPr>
          <p:cNvSpPr txBox="1"/>
          <p:nvPr/>
        </p:nvSpPr>
        <p:spPr>
          <a:xfrm>
            <a:off x="2442592" y="208509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5032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ra1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751630B-518F-0B9F-6F6D-5E945697D388}"/>
              </a:ext>
            </a:extLst>
          </p:cNvPr>
          <p:cNvSpPr/>
          <p:nvPr/>
        </p:nvSpPr>
        <p:spPr>
          <a:xfrm>
            <a:off x="405650" y="1119577"/>
            <a:ext cx="1517468" cy="24405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E00A264C-F631-68E9-54FE-FF11C8C1F6F0}"/>
              </a:ext>
            </a:extLst>
          </p:cNvPr>
          <p:cNvSpPr/>
          <p:nvPr/>
        </p:nvSpPr>
        <p:spPr>
          <a:xfrm>
            <a:off x="2924944" y="1180059"/>
            <a:ext cx="1517468" cy="244059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34</TotalTime>
  <Words>47</Words>
  <Application>Microsoft Office PowerPoint</Application>
  <PresentationFormat>A4 纸张(210x297 毫米)</PresentationFormat>
  <Paragraphs>33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文龙 任</cp:lastModifiedBy>
  <cp:revision>247</cp:revision>
  <dcterms:created xsi:type="dcterms:W3CDTF">2023-02-16T12:33:32Z</dcterms:created>
  <dcterms:modified xsi:type="dcterms:W3CDTF">2024-06-30T12:56:19Z</dcterms:modified>
</cp:coreProperties>
</file>